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7"/>
  </p:handoutMasterIdLst>
  <p:sldIdLst>
    <p:sldId id="275" r:id="rId2"/>
    <p:sldId id="276" r:id="rId3"/>
    <p:sldId id="277" r:id="rId4"/>
    <p:sldId id="278" r:id="rId5"/>
    <p:sldId id="279" r:id="rId6"/>
  </p:sldIdLst>
  <p:sldSz cx="12192000" cy="6858000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480" autoAdjust="0"/>
    <p:restoredTop sz="99771" autoAdjust="0"/>
  </p:normalViewPr>
  <p:slideViewPr>
    <p:cSldViewPr snapToGrid="0">
      <p:cViewPr>
        <p:scale>
          <a:sx n="90" d="100"/>
          <a:sy n="90" d="100"/>
        </p:scale>
        <p:origin x="-1482" y="-6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400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777607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D1374D-5EF5-4C90-82A3-0A2D3EDBE6EB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777607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9E43DA-870D-476A-8C22-9809C69FA9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85302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9979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633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2811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8398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4332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274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6906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0270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9491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7343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6369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1C4E8-72FF-4E9C-B22E-BA837776C713}" type="datetimeFigureOut">
              <a:rPr lang="de-DE" smtClean="0"/>
              <a:t>20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60C05-DFFE-4421-8C80-7D8B257EF23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78736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de-DE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287" y="285420"/>
            <a:ext cx="10058400" cy="4897587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63065" y="6346763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FIGURE S0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4851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9897" y="202697"/>
            <a:ext cx="5178534" cy="20339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5397" y="202697"/>
            <a:ext cx="4480869" cy="18544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286" y="2850983"/>
            <a:ext cx="5519440" cy="21832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1358" y="3185320"/>
            <a:ext cx="5265649" cy="17957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feld 7"/>
          <p:cNvSpPr txBox="1"/>
          <p:nvPr/>
        </p:nvSpPr>
        <p:spPr>
          <a:xfrm>
            <a:off x="109464" y="1470624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a)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6133801" y="1655290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b)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109464" y="4325703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c)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6151712" y="4444745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d)</a:t>
            </a:r>
          </a:p>
        </p:txBody>
      </p:sp>
      <p:sp>
        <p:nvSpPr>
          <p:cNvPr id="14" name="Inhaltsplatzhalter 3"/>
          <p:cNvSpPr txBox="1">
            <a:spLocks noGrp="1"/>
          </p:cNvSpPr>
          <p:nvPr>
            <p:ph idx="1"/>
          </p:nvPr>
        </p:nvSpPr>
        <p:spPr>
          <a:xfrm>
            <a:off x="109464" y="5040136"/>
            <a:ext cx="11923207" cy="17163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indent="0" algn="just">
              <a:buNone/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02 </a:t>
            </a:r>
          </a:p>
          <a:p>
            <a:pPr marL="0" indent="0" algn="just">
              <a:buNone/>
            </a:pP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WNV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itration with specific RT-qPCR (Eiden, 2010). WNV.NY99 RNA new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itrati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urve (right – logarithm scale).  WNV×1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s correctly three time positive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s once positive and once extremely low positive, and once negative. WNV×1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9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WNV×1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egative.					           (b)WNV titration with specific RT-qPCR (Eiden, 2010). WNV.NY99 RNA new titration curve (right – logarithm scale). 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correctly three time positive.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once positive and once extremely low positive, and once negative.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9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re negative.					                  (c)WNV titration with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aviviru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T-qPCR. WNV.NY99 RNA new titration curve (right – logarithm scale). 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correctly three time positive.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three-time low positive.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9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once extremely low positive, and once negative.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re negative. See the corresponding melting curves in panel (d).                                     (d)WNV titration with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aviviru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RT-qPCR (melting curves). WNV.NY99 RNA new titration curve (right – logarithm scale). 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correctly three time positive.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 three-time low positive.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9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 once extremely low positive, and once negative. WNV×10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re negative. </a:t>
            </a:r>
            <a:endParaRPr lang="en-US" sz="1200" dirty="0" smtClean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3338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16"/>
          <a:stretch/>
        </p:blipFill>
        <p:spPr bwMode="auto">
          <a:xfrm>
            <a:off x="984737" y="439738"/>
            <a:ext cx="5108881" cy="1993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1814" y="462906"/>
            <a:ext cx="4793065" cy="1946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7491" y="2602166"/>
            <a:ext cx="4916127" cy="1675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4007" y="2501698"/>
            <a:ext cx="4812914" cy="17658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feld 11"/>
          <p:cNvSpPr txBox="1"/>
          <p:nvPr/>
        </p:nvSpPr>
        <p:spPr>
          <a:xfrm>
            <a:off x="396555" y="1821513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a)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410726" y="3696459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d)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6216344" y="1835684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b)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6209249" y="3742529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d)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21244" y="4465661"/>
            <a:ext cx="12333120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igure </a:t>
            </a:r>
            <a:r>
              <a:rPr lang="en-US" sz="1200" b="1" dirty="0" smtClean="0"/>
              <a:t>S03</a:t>
            </a:r>
            <a:endParaRPr lang="en-US" sz="1200" b="1" dirty="0"/>
          </a:p>
          <a:p>
            <a:pPr marL="228600" indent="-228600">
              <a:buAutoNum type="alphaLcParenBoth"/>
            </a:pPr>
            <a:r>
              <a:rPr lang="en-US" sz="1200" dirty="0" smtClean="0"/>
              <a:t>USUV </a:t>
            </a:r>
            <a:r>
              <a:rPr lang="en-US" sz="1200" dirty="0"/>
              <a:t>titration with specific RT-qPCR (</a:t>
            </a:r>
            <a:r>
              <a:rPr lang="en-US" sz="1200" dirty="0" err="1"/>
              <a:t>Cavrini</a:t>
            </a:r>
            <a:r>
              <a:rPr lang="en-US" sz="1200" dirty="0"/>
              <a:t>, 2011). USUV RNA new titration curve (right – logarithm scale). USUV×10-7 is correctly twice positive. WNV×10-8 is once low positive and </a:t>
            </a:r>
            <a:r>
              <a:rPr lang="en-US" sz="1200" dirty="0" smtClean="0"/>
              <a:t>once</a:t>
            </a:r>
          </a:p>
          <a:p>
            <a:r>
              <a:rPr lang="en-US" sz="1200" dirty="0" smtClean="0"/>
              <a:t> </a:t>
            </a:r>
            <a:r>
              <a:rPr lang="en-US" sz="1200" dirty="0"/>
              <a:t>extremely low positive. WNV×10-9 and WNV×10-10 are negative.</a:t>
            </a:r>
          </a:p>
          <a:p>
            <a:r>
              <a:rPr lang="en-US" sz="1200" dirty="0"/>
              <a:t>(b) USUV titration with specific RT-qPCR (</a:t>
            </a:r>
            <a:r>
              <a:rPr lang="en-US" sz="1200" dirty="0" err="1"/>
              <a:t>Jost</a:t>
            </a:r>
            <a:r>
              <a:rPr lang="en-US" sz="1200" dirty="0"/>
              <a:t>, 2011). USUV RNA new titration curve (right – logarithm scale).  USUV×10-7 is twice positive. USUV×10-8 is once low positive and once extremely </a:t>
            </a:r>
            <a:endParaRPr lang="en-US" sz="1200" dirty="0" smtClean="0"/>
          </a:p>
          <a:p>
            <a:r>
              <a:rPr lang="en-US" sz="1200" dirty="0" smtClean="0"/>
              <a:t>low </a:t>
            </a:r>
            <a:r>
              <a:rPr lang="en-US" sz="1200" dirty="0"/>
              <a:t>positive. WNV×10-9 is once extremely low positive and once negative. USUV×10-10 are negative.</a:t>
            </a:r>
          </a:p>
          <a:p>
            <a:r>
              <a:rPr lang="en-US" sz="1200" dirty="0"/>
              <a:t>(c) USUV titration with </a:t>
            </a:r>
            <a:r>
              <a:rPr lang="en-US" sz="1200" dirty="0" err="1"/>
              <a:t>Flavivirus</a:t>
            </a:r>
            <a:r>
              <a:rPr lang="en-US" sz="1200" dirty="0"/>
              <a:t> RT-qPCR. USUV RNA new titration curve (right – logarithm scale).  USUV×10-6 is correctly twice positive. USUV×10-7 is once extremely low positive and once </a:t>
            </a:r>
            <a:endParaRPr lang="en-US" sz="1200" dirty="0" smtClean="0"/>
          </a:p>
          <a:p>
            <a:r>
              <a:rPr lang="en-US" sz="1200" dirty="0" smtClean="0"/>
              <a:t>negative</a:t>
            </a:r>
            <a:r>
              <a:rPr lang="en-US" sz="1200" dirty="0"/>
              <a:t>. USUV×10-8 are negative. It need more than 30 copies/reaction or 5 copies/µL to be detected. </a:t>
            </a:r>
            <a:r>
              <a:rPr lang="en-US" sz="1200" dirty="0" smtClean="0"/>
              <a:t>Both </a:t>
            </a:r>
            <a:r>
              <a:rPr lang="en-US" sz="1200" dirty="0"/>
              <a:t>USUV specific PCR used were possibly even more sensitive (Figure S3 (a) and (b)), </a:t>
            </a:r>
            <a:endParaRPr lang="en-US" sz="1200" dirty="0" smtClean="0"/>
          </a:p>
          <a:p>
            <a:r>
              <a:rPr lang="en-US" sz="1200" dirty="0" smtClean="0"/>
              <a:t>with </a:t>
            </a:r>
            <a:r>
              <a:rPr lang="en-US" sz="1200" dirty="0"/>
              <a:t>Ct of 28 for the 10-5 USUV RNA dilution, 32 for the 10-6, 35 for the 10-7 and 38-40 for the 10-8 dilution. This is more efficient, with Ct up to 8 cycles smaller than with the new </a:t>
            </a:r>
            <a:r>
              <a:rPr lang="en-US" sz="1200" dirty="0" err="1"/>
              <a:t>Flavivirus</a:t>
            </a:r>
            <a:r>
              <a:rPr lang="en-US" sz="1200" dirty="0"/>
              <a:t> </a:t>
            </a:r>
            <a:endParaRPr lang="en-US" sz="1200" dirty="0" smtClean="0"/>
          </a:p>
          <a:p>
            <a:r>
              <a:rPr lang="en-US" sz="1200" dirty="0" smtClean="0"/>
              <a:t>PCR </a:t>
            </a:r>
            <a:r>
              <a:rPr lang="en-US" sz="1200" dirty="0"/>
              <a:t>which showed in this experiments Ct of 33 for the 10-5 USUV RNA dilution and 36-37 for the 10-6 dilution. We observed using the smelt curve (Figure S3 (c)) that the sensitivity (last detected </a:t>
            </a:r>
            <a:endParaRPr lang="en-US" sz="1200" dirty="0" smtClean="0"/>
          </a:p>
          <a:p>
            <a:r>
              <a:rPr lang="en-US" sz="1200" dirty="0" smtClean="0"/>
              <a:t>dilution</a:t>
            </a:r>
            <a:r>
              <a:rPr lang="en-US" sz="1200" dirty="0"/>
              <a:t>) was at best 10 times smaller (with a low signal for the 10-7 dilution), to allow maximal detection of an estimated 30 copies/reaction.    </a:t>
            </a:r>
          </a:p>
          <a:p>
            <a:r>
              <a:rPr lang="en-US" sz="1200" dirty="0"/>
              <a:t>(d) SLEV titration with </a:t>
            </a:r>
            <a:r>
              <a:rPr lang="en-US" sz="1200" dirty="0" err="1"/>
              <a:t>Flavivirus</a:t>
            </a:r>
            <a:r>
              <a:rPr lang="en-US" sz="1200" dirty="0"/>
              <a:t> RT-PCR. SLEV RNA new titration curve (right – logarithm scale).  SLEV×10-6 is correctly twice positive. SLEV×10-7 and once SLEV×10-8 are extremely low positive</a:t>
            </a:r>
            <a:r>
              <a:rPr lang="en-US" sz="1200" dirty="0" smtClean="0"/>
              <a:t>.</a:t>
            </a:r>
          </a:p>
          <a:p>
            <a:r>
              <a:rPr lang="en-US" sz="1200" dirty="0" smtClean="0"/>
              <a:t> </a:t>
            </a:r>
            <a:r>
              <a:rPr lang="en-US" sz="1200" dirty="0"/>
              <a:t>For TBEV.A and TBEV.H viruses (control RNA) the specific PCR got Ct of 28 and 26 while the </a:t>
            </a:r>
            <a:r>
              <a:rPr lang="en-US" sz="1200" dirty="0" err="1"/>
              <a:t>Flavivirus</a:t>
            </a:r>
            <a:r>
              <a:rPr lang="en-US" sz="1200" dirty="0"/>
              <a:t> PCR got 25.4 and 23.7 respectively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942142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613295" y="-1207462"/>
            <a:ext cx="5967420" cy="93344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70822" y="6152049"/>
            <a:ext cx="1022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ABLE S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7652525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9346" y="874206"/>
            <a:ext cx="7826008" cy="5182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142335" y="5687584"/>
            <a:ext cx="1022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TABLE S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732428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1</Words>
  <Application>Microsoft Office PowerPoint</Application>
  <PresentationFormat>Benutzerdefiniert</PresentationFormat>
  <Paragraphs>25</Paragraphs>
  <Slides>5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6" baseType="lpstr"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rielvina@yahoo.es</dc:creator>
  <cp:lastModifiedBy>Eiden, Martin</cp:lastModifiedBy>
  <cp:revision>71</cp:revision>
  <cp:lastPrinted>2016-12-15T07:50:45Z</cp:lastPrinted>
  <dcterms:created xsi:type="dcterms:W3CDTF">2015-10-05T06:32:07Z</dcterms:created>
  <dcterms:modified xsi:type="dcterms:W3CDTF">2016-12-20T12:11:04Z</dcterms:modified>
</cp:coreProperties>
</file>